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8" r:id="rId2"/>
    <p:sldId id="283" r:id="rId3"/>
    <p:sldId id="279" r:id="rId4"/>
    <p:sldId id="280" r:id="rId5"/>
    <p:sldId id="282" r:id="rId6"/>
    <p:sldId id="27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65857" autoAdjust="0"/>
  </p:normalViewPr>
  <p:slideViewPr>
    <p:cSldViewPr snapToGrid="0">
      <p:cViewPr varScale="1">
        <p:scale>
          <a:sx n="75" d="100"/>
          <a:sy n="75" d="100"/>
        </p:scale>
        <p:origin x="18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B063F7-8D45-41DA-8B9D-59188D32909D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752F3D-69B8-4756-80D1-CBBF201AC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632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.</a:t>
            </a:r>
            <a:r>
              <a:rPr lang="en-US" dirty="0"/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. Maspin in myoepithelial cells layer. </a:t>
            </a:r>
            <a:r>
              <a:rPr lang="en-US" sz="1200" b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spin expression at the epithelial edge of acini.</a:t>
            </a:r>
            <a:endParaRPr lang="en-US" b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F72117-DE85-4EB5-A893-F94138EA1B4D}" type="slidenum">
              <a:rPr lang="pt-BR" smtClean="0"/>
              <a:t>2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56802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2: Kaplan-Meier curves for overall survival (OS) and disease-free survival (DFS) of patients with breast cancer stratified according to MASPIN expression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OS curves (A, B and C) and DFS curves (D, E and F) were calculated for each group of patients. All cases were classified as high or low expression for MASPIN. A and D - Evaluation of cytoplasmic immunostaining. B and E - Evaluation of nuclear immunostaining. C and F - Stromal immunostaining assessmen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F72117-DE85-4EB5-A893-F94138EA1B4D}" type="slidenum">
              <a:rPr lang="pt-BR" smtClean="0"/>
              <a:t>3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293277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3: Kaplan-Meier curves for overall survival (OS) and disease-free survival (DFS) of patients with breast cancer of the Luminal subtype stratified according to the MASPIN expression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OS curves (A, B and C) and DFS curves (D, E and F) were calculated for each group of patients. All cases were classified as high or low expression for MASPIN. A and D - Evaluation of cytoplasmic immunostaining. B and E - Evaluation of nuclear immunostaining. C and F - Stromal immunostaining </a:t>
            </a:r>
            <a:r>
              <a:rPr lang="en-US" sz="1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ment.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F72117-DE85-4EB5-A893-F94138EA1B4D}" type="slidenum">
              <a:rPr lang="pt-BR" smtClean="0"/>
              <a:t>4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872333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/>
              <a:t>Supp.</a:t>
            </a:r>
            <a:r>
              <a:rPr lang="en-US" sz="1800" dirty="0"/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4: Kaplan-Meier curves for overall survival (OS) and disease-free survival (DFS) of patients with breast cancer of the HER2+ subtype stratified according to the MASPIN expression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OS curves (A, B and C) and DFS curves (D, E and F) were calculated for each group of patients. All cases were classified as high or low expression for MASPIN. A and D - Evaluation of cytoplasmic immunostaining. B and E - Evaluation of nuclear immunostaining. C and F - Stromal immunostaining assessmen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F72117-DE85-4EB5-A893-F94138EA1B4D}" type="slidenum">
              <a:rPr lang="pt-BR" smtClean="0"/>
              <a:t>5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351590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. Figure 5.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man breast cancer cell lines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spin expression profile in breast lines MCF-10A, MCF7, MDA-MB-231 and HS-578T., </a:t>
            </a:r>
            <a:endParaRPr lang="pt-B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865AB73-95A4-4D61-BA88-4CE188B9695C}" type="slidenum">
              <a:rPr kumimoji="0" lang="pt-B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pt-B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96568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AFEC5-80CB-4674-B4B7-F491B5A435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3E70EA-8B18-409F-808D-6139AF4886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48EF4-E0BF-4AB3-8145-1D29B6BB0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F384E-7488-49A5-A554-4B1CA99D3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DE943A-9616-4841-A76F-6FA41E16D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942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88081-16F9-4954-A4D1-1DACC2E0A4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80C492-31A9-49A6-BF26-BF913270E1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3BDF1C-771E-4D5D-99A6-AAFA44817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4F803-0786-4A0D-BE96-52058F371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44119E-41A7-460B-8409-98591466A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240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F454F3-BCA1-43E3-8586-A688DF55FE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479CD2-99B1-41B5-A327-517FF2270B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8DB72-2AF5-469A-B647-725B276DD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F061BA-77A3-4D5F-A429-A97DBF037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F9D2C-6D68-4A66-8462-A269B1F8F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27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04A60-32F0-49CE-B77B-38285D39C0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D3BFBF-8877-4BEB-BE90-5CFB74B80C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D5913-6E68-428D-A871-DD4348C5F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F6C06-EC05-4206-B8ED-3469B9445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66C1DD-7914-4DC3-8181-4F45F25CA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164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EEA60-C410-4C42-994C-F6737D049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327546-786A-4D19-B7EC-6A53C46E35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E0286D-5131-4680-8659-B2B2C9AAB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7139D-00F9-4AE5-877E-C119B73C7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68CC2-E23B-46D8-8390-FD05D1A95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419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EBAE2F-024C-4433-841E-EFD493B1D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923A0B-4B10-481A-BFEC-256CCA8C24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E283CA-51F8-4F4B-B21C-5DA52E248E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968BDE-DCE9-44C8-8A76-84818BAB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A4303A-5A04-4EBA-8B49-4805A1978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30C7B7-BD88-4FEE-96B9-6511F5295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634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57272-ED32-4967-B524-A04EB9EE5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878C87-ED1D-483C-AD49-A7B8F9554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05D4C8-EAB5-44D5-927F-47A100BC11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2E4D9E-E69D-4F6B-B07E-DABD8335C4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618ED2-C725-4C12-8C8D-A6FD07666A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94E949-8A44-4347-A4B5-EE45A7858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4429D9-D147-4E7F-A3A6-2B25E0727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1692F3-2941-4272-8993-90EEA06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79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6D3799-99DD-43C3-92F3-56E1C49FFF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D0A7C4-FC47-40A3-B376-B1394B0D0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11376D-4C99-4C4B-989A-58230B128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BBADD6-12C8-4F34-9ADE-4D26E87D8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304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2CB70E-05F0-4C1C-8F53-E989E70B9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538105-5B78-4D4E-95E8-F99C35FF2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F72BB1-2D25-475C-88F7-918598F86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243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B4698-14D2-417A-A0BD-51994C8E2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771D19-082B-4C50-BAB1-9F49352A46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B02F45-EE45-4399-9F46-7C1DB6680D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BDCBB8-608D-4CE8-891B-F8DACFA1E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914E1F-333E-4949-9997-63007A150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356F23-D862-4E02-91D1-1D8DD068B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688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7FC293-7784-4B9D-A76B-F273B4682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385B52-4260-4254-AAEB-FAAA32F825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57C1F9-CDAA-40D4-8B41-F827204AFA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B9A3B-67C5-4961-9405-6D9268A20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A3AAAF-9974-4F41-82EA-0CD979928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8A4AEE-1939-4866-B881-AE83CA353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809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818586-DBAB-4DE8-A7B7-2E18F6A43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3F1187-AE94-4245-959C-0B66DCC70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3A2B9A-2F61-4958-BC5A-D7AF0586E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DA7EA-ABE9-40F0-AD17-65CD2E33DDB2}" type="datetimeFigureOut">
              <a:rPr lang="en-US" smtClean="0"/>
              <a:t>12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D269F8-0FC5-4B71-82DE-18A8BFA8EC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D21B08-451B-4883-9887-E1D8B8331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02AFE-021A-4443-8F5D-F8C81DCC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994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microsoft.com/office/2007/relationships/hdphoto" Target="../media/hdphoto1.wdp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9262313-B8DA-4464-9296-4CF112524CC8}"/>
              </a:ext>
            </a:extLst>
          </p:cNvPr>
          <p:cNvSpPr txBox="1"/>
          <p:nvPr/>
        </p:nvSpPr>
        <p:spPr>
          <a:xfrm>
            <a:off x="2794604" y="1430787"/>
            <a:ext cx="6515914" cy="4081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52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2497050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F0A0881-1736-2154-1596-5EAF3B1FE5D5}"/>
              </a:ext>
            </a:extLst>
          </p:cNvPr>
          <p:cNvGrpSpPr>
            <a:grpSpLocks noChangeAspect="1"/>
          </p:cNvGrpSpPr>
          <p:nvPr/>
        </p:nvGrpSpPr>
        <p:grpSpPr>
          <a:xfrm>
            <a:off x="3368383" y="1330387"/>
            <a:ext cx="5455234" cy="4131600"/>
            <a:chOff x="1365163" y="1"/>
            <a:chExt cx="7963073" cy="6030948"/>
          </a:xfrm>
        </p:grpSpPr>
        <p:pic>
          <p:nvPicPr>
            <p:cNvPr id="3" name="Picture 2" descr="A close-up of a cell">
              <a:extLst>
                <a:ext uri="{FF2B5EF4-FFF2-40B4-BE49-F238E27FC236}">
                  <a16:creationId xmlns:a16="http://schemas.microsoft.com/office/drawing/2014/main" id="{F4DBCFA9-1E20-2C2C-C915-6C4220D52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65163" y="1"/>
              <a:ext cx="7963073" cy="5943600"/>
            </a:xfrm>
            <a:prstGeom prst="rect">
              <a:avLst/>
            </a:prstGeom>
          </p:spPr>
        </p:pic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89053C20-2135-3377-33EB-EE8341B305AC}"/>
                </a:ext>
              </a:extLst>
            </p:cNvPr>
            <p:cNvCxnSpPr>
              <a:cxnSpLocks/>
            </p:cNvCxnSpPr>
            <p:nvPr/>
          </p:nvCxnSpPr>
          <p:spPr>
            <a:xfrm>
              <a:off x="5499100" y="5486400"/>
              <a:ext cx="1219200" cy="0"/>
            </a:xfrm>
            <a:prstGeom prst="line">
              <a:avLst/>
            </a:prstGeom>
            <a:ln w="444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8E69CE1-DE27-59C7-FAC8-31E025DCF6D5}"/>
                </a:ext>
              </a:extLst>
            </p:cNvPr>
            <p:cNvSpPr txBox="1"/>
            <p:nvPr/>
          </p:nvSpPr>
          <p:spPr>
            <a:xfrm>
              <a:off x="5662904" y="5486402"/>
              <a:ext cx="1249988" cy="544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24" b="1" dirty="0"/>
                <a:t>100u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94971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041">
            <a:extLst>
              <a:ext uri="{FF2B5EF4-FFF2-40B4-BE49-F238E27FC236}">
                <a16:creationId xmlns:a16="http://schemas.microsoft.com/office/drawing/2014/main" id="{30208699-B9EC-44A4-987D-C600714A3E9E}"/>
              </a:ext>
            </a:extLst>
          </p:cNvPr>
          <p:cNvGrpSpPr/>
          <p:nvPr/>
        </p:nvGrpSpPr>
        <p:grpSpPr>
          <a:xfrm>
            <a:off x="382810" y="561998"/>
            <a:ext cx="11426381" cy="6069574"/>
            <a:chOff x="-1764983" y="1081723"/>
            <a:chExt cx="10021888" cy="5323522"/>
          </a:xfrm>
        </p:grpSpPr>
        <p:pic>
          <p:nvPicPr>
            <p:cNvPr id="3" name="Imagem 1030">
              <a:extLst>
                <a:ext uri="{FF2B5EF4-FFF2-40B4-BE49-F238E27FC236}">
                  <a16:creationId xmlns:a16="http://schemas.microsoft.com/office/drawing/2014/main" id="{0472095B-B91A-453A-BC49-DAFD8237CD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598295" y="1153478"/>
              <a:ext cx="3239770" cy="2595245"/>
            </a:xfrm>
            <a:prstGeom prst="rect">
              <a:avLst/>
            </a:prstGeom>
            <a:noFill/>
          </p:spPr>
        </p:pic>
        <p:pic>
          <p:nvPicPr>
            <p:cNvPr id="4" name="Imagem 1029">
              <a:extLst>
                <a:ext uri="{FF2B5EF4-FFF2-40B4-BE49-F238E27FC236}">
                  <a16:creationId xmlns:a16="http://schemas.microsoft.com/office/drawing/2014/main" id="{585AC2C7-0163-4F37-9F5A-7EF708F4CD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1965" y="1130300"/>
              <a:ext cx="3164205" cy="2595245"/>
            </a:xfrm>
            <a:prstGeom prst="rect">
              <a:avLst/>
            </a:prstGeom>
            <a:noFill/>
          </p:spPr>
        </p:pic>
        <p:sp>
          <p:nvSpPr>
            <p:cNvPr id="5" name="Retângulo 43">
              <a:extLst>
                <a:ext uri="{FF2B5EF4-FFF2-40B4-BE49-F238E27FC236}">
                  <a16:creationId xmlns:a16="http://schemas.microsoft.com/office/drawing/2014/main" id="{05BBF46C-CFAD-4631-940E-9E0E0CDF5CC1}"/>
                </a:ext>
              </a:extLst>
            </p:cNvPr>
            <p:cNvSpPr/>
            <p:nvPr/>
          </p:nvSpPr>
          <p:spPr>
            <a:xfrm>
              <a:off x="-1764983" y="1106170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tângulo 1035">
              <a:extLst>
                <a:ext uri="{FF2B5EF4-FFF2-40B4-BE49-F238E27FC236}">
                  <a16:creationId xmlns:a16="http://schemas.microsoft.com/office/drawing/2014/main" id="{D8D5E5D9-DA5E-431A-A2E6-511DFC3F4676}"/>
                </a:ext>
              </a:extLst>
            </p:cNvPr>
            <p:cNvSpPr/>
            <p:nvPr/>
          </p:nvSpPr>
          <p:spPr>
            <a:xfrm>
              <a:off x="1781175" y="1081723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Agrupar 1040">
              <a:extLst>
                <a:ext uri="{FF2B5EF4-FFF2-40B4-BE49-F238E27FC236}">
                  <a16:creationId xmlns:a16="http://schemas.microsoft.com/office/drawing/2014/main" id="{47AB3975-301F-4F87-95FF-01CA046AAECE}"/>
                </a:ext>
              </a:extLst>
            </p:cNvPr>
            <p:cNvGrpSpPr/>
            <p:nvPr/>
          </p:nvGrpSpPr>
          <p:grpSpPr>
            <a:xfrm>
              <a:off x="-1487805" y="1093153"/>
              <a:ext cx="9744710" cy="5312092"/>
              <a:chOff x="-1487805" y="-1430972"/>
              <a:chExt cx="9744710" cy="5312092"/>
            </a:xfrm>
          </p:grpSpPr>
          <p:pic>
            <p:nvPicPr>
              <p:cNvPr id="8" name="Imagem 1031">
                <a:extLst>
                  <a:ext uri="{FF2B5EF4-FFF2-40B4-BE49-F238E27FC236}">
                    <a16:creationId xmlns:a16="http://schemas.microsoft.com/office/drawing/2014/main" id="{008BF2EB-CF13-45C9-A763-298DC1FC9F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64430" y="-1388427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9" name="Imagem 1032">
                <a:extLst>
                  <a:ext uri="{FF2B5EF4-FFF2-40B4-BE49-F238E27FC236}">
                    <a16:creationId xmlns:a16="http://schemas.microsoft.com/office/drawing/2014/main" id="{2E905F92-ADFD-48C3-B636-CD42BB7237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487805" y="1275080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0" name="Imagem 1033">
                <a:extLst>
                  <a:ext uri="{FF2B5EF4-FFF2-40B4-BE49-F238E27FC236}">
                    <a16:creationId xmlns:a16="http://schemas.microsoft.com/office/drawing/2014/main" id="{79CB6A64-B11C-48B3-8A2A-56030552B9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39265" y="1285875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1" name="Imagem 1034">
                <a:extLst>
                  <a:ext uri="{FF2B5EF4-FFF2-40B4-BE49-F238E27FC236}">
                    <a16:creationId xmlns:a16="http://schemas.microsoft.com/office/drawing/2014/main" id="{55A1B321-9ACA-4412-B1A0-F37F816F40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17135" y="1275080"/>
                <a:ext cx="3239770" cy="2595245"/>
              </a:xfrm>
              <a:prstGeom prst="rect">
                <a:avLst/>
              </a:prstGeom>
              <a:noFill/>
            </p:spPr>
          </p:pic>
          <p:sp>
            <p:nvSpPr>
              <p:cNvPr id="12" name="Retângulo 1036">
                <a:extLst>
                  <a:ext uri="{FF2B5EF4-FFF2-40B4-BE49-F238E27FC236}">
                    <a16:creationId xmlns:a16="http://schemas.microsoft.com/office/drawing/2014/main" id="{CB30084E-8442-40C9-9909-741EBECB8512}"/>
                  </a:ext>
                </a:extLst>
              </p:cNvPr>
              <p:cNvSpPr/>
              <p:nvPr/>
            </p:nvSpPr>
            <p:spPr>
              <a:xfrm>
                <a:off x="5040630" y="-1430972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C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tângulo 1037">
                <a:extLst>
                  <a:ext uri="{FF2B5EF4-FFF2-40B4-BE49-F238E27FC236}">
                    <a16:creationId xmlns:a16="http://schemas.microsoft.com/office/drawing/2014/main" id="{190D0427-9224-4AE9-A9C4-6D1D31EBFC5B}"/>
                  </a:ext>
                </a:extLst>
              </p:cNvPr>
              <p:cNvSpPr/>
              <p:nvPr/>
            </p:nvSpPr>
            <p:spPr>
              <a:xfrm>
                <a:off x="-1411605" y="1253173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 dirty="0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D</a:t>
                </a:r>
                <a:endParaRPr lang="en-US" sz="1254" dirty="0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tângulo 1038">
                <a:extLst>
                  <a:ext uri="{FF2B5EF4-FFF2-40B4-BE49-F238E27FC236}">
                    <a16:creationId xmlns:a16="http://schemas.microsoft.com/office/drawing/2014/main" id="{E7E8754F-5ED4-4DF7-ACCF-B1E79FC5A177}"/>
                  </a:ext>
                </a:extLst>
              </p:cNvPr>
              <p:cNvSpPr/>
              <p:nvPr/>
            </p:nvSpPr>
            <p:spPr>
              <a:xfrm>
                <a:off x="1828165" y="1209358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 dirty="0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E</a:t>
                </a:r>
                <a:endParaRPr lang="en-US" sz="1254" dirty="0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tângulo 1039">
                <a:extLst>
                  <a:ext uri="{FF2B5EF4-FFF2-40B4-BE49-F238E27FC236}">
                    <a16:creationId xmlns:a16="http://schemas.microsoft.com/office/drawing/2014/main" id="{EA55F0C6-37FD-44E2-BCF1-ED6B3F42DC83}"/>
                  </a:ext>
                </a:extLst>
              </p:cNvPr>
              <p:cNvSpPr/>
              <p:nvPr/>
            </p:nvSpPr>
            <p:spPr>
              <a:xfrm>
                <a:off x="5093335" y="1243648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 dirty="0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F</a:t>
                </a:r>
                <a:endParaRPr lang="en-US" sz="1254" dirty="0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" name="CaixaDeTexto 4">
            <a:extLst>
              <a:ext uri="{FF2B5EF4-FFF2-40B4-BE49-F238E27FC236}">
                <a16:creationId xmlns:a16="http://schemas.microsoft.com/office/drawing/2014/main" id="{F6420171-2E06-4B79-A758-315ECB2A8F3B}"/>
              </a:ext>
            </a:extLst>
          </p:cNvPr>
          <p:cNvSpPr txBox="1"/>
          <p:nvPr/>
        </p:nvSpPr>
        <p:spPr>
          <a:xfrm>
            <a:off x="2125971" y="394594"/>
            <a:ext cx="78233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Cytoplasm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ixaDeTexto 4">
            <a:extLst>
              <a:ext uri="{FF2B5EF4-FFF2-40B4-BE49-F238E27FC236}">
                <a16:creationId xmlns:a16="http://schemas.microsoft.com/office/drawing/2014/main" id="{3CCD389C-C188-4C70-858D-4CDDBDD07A17}"/>
              </a:ext>
            </a:extLst>
          </p:cNvPr>
          <p:cNvSpPr txBox="1"/>
          <p:nvPr/>
        </p:nvSpPr>
        <p:spPr>
          <a:xfrm>
            <a:off x="5835303" y="377580"/>
            <a:ext cx="613181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Nuclear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ixaDeTexto 4">
            <a:extLst>
              <a:ext uri="{FF2B5EF4-FFF2-40B4-BE49-F238E27FC236}">
                <a16:creationId xmlns:a16="http://schemas.microsoft.com/office/drawing/2014/main" id="{3C072EC7-6CAD-4244-AC8A-9D3B204854E7}"/>
              </a:ext>
            </a:extLst>
          </p:cNvPr>
          <p:cNvSpPr txBox="1"/>
          <p:nvPr/>
        </p:nvSpPr>
        <p:spPr>
          <a:xfrm>
            <a:off x="9668350" y="377580"/>
            <a:ext cx="61799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Stromal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1D28E422-CC2E-429A-AE8B-D4D8D7497A5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982997" y="2914967"/>
            <a:ext cx="863178" cy="28772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B5466B0-58C4-49B8-BD0D-C08D0AF438A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806031" y="2916357"/>
            <a:ext cx="863178" cy="28772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D6A94F5-F7E7-497D-9CD2-9B13B4F978A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455033" y="2900487"/>
            <a:ext cx="863178" cy="28772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02C637B-8320-4D23-827E-3D98F7D0F63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1122367" y="5948184"/>
            <a:ext cx="863178" cy="28772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8EA992A-6416-4058-A0EB-D5AF16287D7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798428" y="5948487"/>
            <a:ext cx="863178" cy="28772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4337AE6-D223-44AB-8371-0728A49EAF9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528609" y="5948487"/>
            <a:ext cx="863178" cy="287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8895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059">
            <a:extLst>
              <a:ext uri="{FF2B5EF4-FFF2-40B4-BE49-F238E27FC236}">
                <a16:creationId xmlns:a16="http://schemas.microsoft.com/office/drawing/2014/main" id="{2D49BC2E-6F26-4DEB-9AA7-0162319F0B63}"/>
              </a:ext>
            </a:extLst>
          </p:cNvPr>
          <p:cNvGrpSpPr/>
          <p:nvPr/>
        </p:nvGrpSpPr>
        <p:grpSpPr>
          <a:xfrm>
            <a:off x="390593" y="643809"/>
            <a:ext cx="11410814" cy="6173467"/>
            <a:chOff x="-2107565" y="902335"/>
            <a:chExt cx="10008235" cy="5414645"/>
          </a:xfrm>
        </p:grpSpPr>
        <p:pic>
          <p:nvPicPr>
            <p:cNvPr id="3" name="Imagem 1045">
              <a:extLst>
                <a:ext uri="{FF2B5EF4-FFF2-40B4-BE49-F238E27FC236}">
                  <a16:creationId xmlns:a16="http://schemas.microsoft.com/office/drawing/2014/main" id="{3E0D437D-6D19-4C22-B01E-D2C37C2FC0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107565" y="902335"/>
              <a:ext cx="3239770" cy="2595245"/>
            </a:xfrm>
            <a:prstGeom prst="rect">
              <a:avLst/>
            </a:prstGeom>
            <a:noFill/>
          </p:spPr>
        </p:pic>
        <p:pic>
          <p:nvPicPr>
            <p:cNvPr id="4" name="Imagem 1046">
              <a:extLst>
                <a:ext uri="{FF2B5EF4-FFF2-40B4-BE49-F238E27FC236}">
                  <a16:creationId xmlns:a16="http://schemas.microsoft.com/office/drawing/2014/main" id="{D6E0BA85-38BD-4FB9-A553-DE65CE6B9F4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4135" y="902335"/>
              <a:ext cx="3239770" cy="2595245"/>
            </a:xfrm>
            <a:prstGeom prst="rect">
              <a:avLst/>
            </a:prstGeom>
            <a:noFill/>
          </p:spPr>
        </p:pic>
        <p:sp>
          <p:nvSpPr>
            <p:cNvPr id="5" name="Retângulo 1051">
              <a:extLst>
                <a:ext uri="{FF2B5EF4-FFF2-40B4-BE49-F238E27FC236}">
                  <a16:creationId xmlns:a16="http://schemas.microsoft.com/office/drawing/2014/main" id="{19965CF3-2F2D-434B-9AFC-8DF53DC07822}"/>
                </a:ext>
              </a:extLst>
            </p:cNvPr>
            <p:cNvSpPr/>
            <p:nvPr/>
          </p:nvSpPr>
          <p:spPr>
            <a:xfrm>
              <a:off x="-2021840" y="902335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tângulo 1052">
              <a:extLst>
                <a:ext uri="{FF2B5EF4-FFF2-40B4-BE49-F238E27FC236}">
                  <a16:creationId xmlns:a16="http://schemas.microsoft.com/office/drawing/2014/main" id="{7343BB45-D446-405E-937B-2B0661D77224}"/>
                </a:ext>
              </a:extLst>
            </p:cNvPr>
            <p:cNvSpPr/>
            <p:nvPr/>
          </p:nvSpPr>
          <p:spPr>
            <a:xfrm>
              <a:off x="1419860" y="902335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Agrupar 1058">
              <a:extLst>
                <a:ext uri="{FF2B5EF4-FFF2-40B4-BE49-F238E27FC236}">
                  <a16:creationId xmlns:a16="http://schemas.microsoft.com/office/drawing/2014/main" id="{4657AE37-78ED-4153-B5C8-699278696CBD}"/>
                </a:ext>
              </a:extLst>
            </p:cNvPr>
            <p:cNvGrpSpPr/>
            <p:nvPr/>
          </p:nvGrpSpPr>
          <p:grpSpPr>
            <a:xfrm>
              <a:off x="-2107565" y="902335"/>
              <a:ext cx="10008235" cy="5414645"/>
              <a:chOff x="-2107565" y="-1659890"/>
              <a:chExt cx="10008235" cy="5414645"/>
            </a:xfrm>
          </p:grpSpPr>
          <p:pic>
            <p:nvPicPr>
              <p:cNvPr id="8" name="Imagem 1047">
                <a:extLst>
                  <a:ext uri="{FF2B5EF4-FFF2-40B4-BE49-F238E27FC236}">
                    <a16:creationId xmlns:a16="http://schemas.microsoft.com/office/drawing/2014/main" id="{BC64E88D-E554-4F35-9D82-1556223B51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59630" y="-1659890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9" name="Imagem 1048">
                <a:extLst>
                  <a:ext uri="{FF2B5EF4-FFF2-40B4-BE49-F238E27FC236}">
                    <a16:creationId xmlns:a16="http://schemas.microsoft.com/office/drawing/2014/main" id="{353E0C86-071E-40FD-AA29-717DE424CF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2107565" y="1083310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0" name="Imagem 1049">
                <a:extLst>
                  <a:ext uri="{FF2B5EF4-FFF2-40B4-BE49-F238E27FC236}">
                    <a16:creationId xmlns:a16="http://schemas.microsoft.com/office/drawing/2014/main" id="{BCBF3B2E-F83E-463B-B977-F1E056C83C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34135" y="1134110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1" name="Imagem 1050">
                <a:extLst>
                  <a:ext uri="{FF2B5EF4-FFF2-40B4-BE49-F238E27FC236}">
                    <a16:creationId xmlns:a16="http://schemas.microsoft.com/office/drawing/2014/main" id="{1A43B273-F9CF-4D6D-BD1B-D35163CF07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60900" y="1159510"/>
                <a:ext cx="3239770" cy="2595245"/>
              </a:xfrm>
              <a:prstGeom prst="rect">
                <a:avLst/>
              </a:prstGeom>
              <a:noFill/>
            </p:spPr>
          </p:pic>
          <p:sp>
            <p:nvSpPr>
              <p:cNvPr id="12" name="Retângulo 1053">
                <a:extLst>
                  <a:ext uri="{FF2B5EF4-FFF2-40B4-BE49-F238E27FC236}">
                    <a16:creationId xmlns:a16="http://schemas.microsoft.com/office/drawing/2014/main" id="{90A4364C-23A5-4142-93D7-81419C005A6F}"/>
                  </a:ext>
                </a:extLst>
              </p:cNvPr>
              <p:cNvSpPr/>
              <p:nvPr/>
            </p:nvSpPr>
            <p:spPr>
              <a:xfrm>
                <a:off x="4745355" y="-1659890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C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tângulo 1055">
                <a:extLst>
                  <a:ext uri="{FF2B5EF4-FFF2-40B4-BE49-F238E27FC236}">
                    <a16:creationId xmlns:a16="http://schemas.microsoft.com/office/drawing/2014/main" id="{FB051129-09FF-4326-AC1F-C28158F91F42}"/>
                  </a:ext>
                </a:extLst>
              </p:cNvPr>
              <p:cNvSpPr/>
              <p:nvPr/>
            </p:nvSpPr>
            <p:spPr>
              <a:xfrm>
                <a:off x="-2021840" y="1083310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D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tângulo 1056">
                <a:extLst>
                  <a:ext uri="{FF2B5EF4-FFF2-40B4-BE49-F238E27FC236}">
                    <a16:creationId xmlns:a16="http://schemas.microsoft.com/office/drawing/2014/main" id="{F973F200-93B1-4BEB-BE42-D603677E19A1}"/>
                  </a:ext>
                </a:extLst>
              </p:cNvPr>
              <p:cNvSpPr/>
              <p:nvPr/>
            </p:nvSpPr>
            <p:spPr>
              <a:xfrm>
                <a:off x="1419860" y="1134110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E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tângulo 1057">
                <a:extLst>
                  <a:ext uri="{FF2B5EF4-FFF2-40B4-BE49-F238E27FC236}">
                    <a16:creationId xmlns:a16="http://schemas.microsoft.com/office/drawing/2014/main" id="{7C328B78-82D7-4B68-976B-E5539D2F7EB2}"/>
                  </a:ext>
                </a:extLst>
              </p:cNvPr>
              <p:cNvSpPr/>
              <p:nvPr/>
            </p:nvSpPr>
            <p:spPr>
              <a:xfrm>
                <a:off x="4746625" y="1149985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F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471F11DC-2AB9-4369-8B3E-9F51B9704A2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16118" y="2924379"/>
            <a:ext cx="863178" cy="28772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F9C0E0E-4676-4C5F-A39B-2BD806ACE30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740146" y="2931619"/>
            <a:ext cx="863178" cy="28772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791AA77-3A39-4DDA-AB85-8DD46100277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525983" y="2931619"/>
            <a:ext cx="863178" cy="28772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781D481-67A2-4B27-9E9E-D83321269A9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787158" y="6066498"/>
            <a:ext cx="863178" cy="28772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C0CCB36-3742-43D0-AFC5-D8E4A2A9863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718426" y="6117177"/>
            <a:ext cx="863178" cy="28772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DAE9076-3DB1-4AD1-A49C-E77C33D711D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533857" y="6155245"/>
            <a:ext cx="863178" cy="287728"/>
          </a:xfrm>
          <a:prstGeom prst="rect">
            <a:avLst/>
          </a:prstGeom>
        </p:spPr>
      </p:pic>
      <p:sp>
        <p:nvSpPr>
          <p:cNvPr id="22" name="CaixaDeTexto 4">
            <a:extLst>
              <a:ext uri="{FF2B5EF4-FFF2-40B4-BE49-F238E27FC236}">
                <a16:creationId xmlns:a16="http://schemas.microsoft.com/office/drawing/2014/main" id="{5D1435C3-1CC4-405A-8121-3F256714139E}"/>
              </a:ext>
            </a:extLst>
          </p:cNvPr>
          <p:cNvSpPr txBox="1"/>
          <p:nvPr/>
        </p:nvSpPr>
        <p:spPr>
          <a:xfrm>
            <a:off x="1855517" y="436646"/>
            <a:ext cx="78233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Cytoplasm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ixaDeTexto 4">
            <a:extLst>
              <a:ext uri="{FF2B5EF4-FFF2-40B4-BE49-F238E27FC236}">
                <a16:creationId xmlns:a16="http://schemas.microsoft.com/office/drawing/2014/main" id="{0ECB565B-609A-47BC-B6DA-2573AFC6D33C}"/>
              </a:ext>
            </a:extLst>
          </p:cNvPr>
          <p:cNvSpPr txBox="1"/>
          <p:nvPr/>
        </p:nvSpPr>
        <p:spPr>
          <a:xfrm>
            <a:off x="5897347" y="436646"/>
            <a:ext cx="613181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Nuclear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ixaDeTexto 4">
            <a:extLst>
              <a:ext uri="{FF2B5EF4-FFF2-40B4-BE49-F238E27FC236}">
                <a16:creationId xmlns:a16="http://schemas.microsoft.com/office/drawing/2014/main" id="{B51ABEA6-9C88-41E1-A5A4-72DB4E32F7F4}"/>
              </a:ext>
            </a:extLst>
          </p:cNvPr>
          <p:cNvSpPr txBox="1"/>
          <p:nvPr/>
        </p:nvSpPr>
        <p:spPr>
          <a:xfrm>
            <a:off x="9630916" y="436646"/>
            <a:ext cx="61799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Stromal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45EA144-B49A-4AFB-B162-1F6DC5E327B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45440" y="2938859"/>
            <a:ext cx="863178" cy="28772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9C562C1-1FC0-43D3-B223-29210EABF58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763677" y="2925045"/>
            <a:ext cx="863178" cy="28772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F2540F8-B1ED-4AFE-89C1-C624E529F10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528609" y="2926551"/>
            <a:ext cx="863178" cy="28772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B432B67-7B16-4C4C-B378-D0B95AA19C9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12045" y="6069090"/>
            <a:ext cx="863178" cy="28772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BFBCC66-E4D1-4071-9F9D-E498B4132F8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746301" y="6121218"/>
            <a:ext cx="863178" cy="28772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06D6054-6C90-4D27-A28F-3FE8A286065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528609" y="6147281"/>
            <a:ext cx="863178" cy="287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060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073">
            <a:extLst>
              <a:ext uri="{FF2B5EF4-FFF2-40B4-BE49-F238E27FC236}">
                <a16:creationId xmlns:a16="http://schemas.microsoft.com/office/drawing/2014/main" id="{FB663A9E-5382-4214-A93E-F7CD0562C445}"/>
              </a:ext>
            </a:extLst>
          </p:cNvPr>
          <p:cNvGrpSpPr/>
          <p:nvPr/>
        </p:nvGrpSpPr>
        <p:grpSpPr>
          <a:xfrm>
            <a:off x="406314" y="899377"/>
            <a:ext cx="11379373" cy="5917898"/>
            <a:chOff x="-2055177" y="907097"/>
            <a:chExt cx="9980658" cy="5190490"/>
          </a:xfrm>
        </p:grpSpPr>
        <p:pic>
          <p:nvPicPr>
            <p:cNvPr id="3" name="Imagem 1060">
              <a:extLst>
                <a:ext uri="{FF2B5EF4-FFF2-40B4-BE49-F238E27FC236}">
                  <a16:creationId xmlns:a16="http://schemas.microsoft.com/office/drawing/2014/main" id="{46B1C7E0-F434-45D3-8AD8-BAB4099409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055177" y="907097"/>
              <a:ext cx="3239770" cy="2595245"/>
            </a:xfrm>
            <a:prstGeom prst="rect">
              <a:avLst/>
            </a:prstGeom>
            <a:noFill/>
          </p:spPr>
        </p:pic>
        <p:pic>
          <p:nvPicPr>
            <p:cNvPr id="4" name="Imagem 1061">
              <a:extLst>
                <a:ext uri="{FF2B5EF4-FFF2-40B4-BE49-F238E27FC236}">
                  <a16:creationId xmlns:a16="http://schemas.microsoft.com/office/drawing/2014/main" id="{B9E6A92B-375C-4B31-BABF-64F608667A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4016" y="907097"/>
              <a:ext cx="3239770" cy="2595245"/>
            </a:xfrm>
            <a:prstGeom prst="rect">
              <a:avLst/>
            </a:prstGeom>
            <a:noFill/>
          </p:spPr>
        </p:pic>
        <p:sp>
          <p:nvSpPr>
            <p:cNvPr id="5" name="Retângulo 1066">
              <a:extLst>
                <a:ext uri="{FF2B5EF4-FFF2-40B4-BE49-F238E27FC236}">
                  <a16:creationId xmlns:a16="http://schemas.microsoft.com/office/drawing/2014/main" id="{A29250E8-AAF0-4792-864F-815F1398431D}"/>
                </a:ext>
              </a:extLst>
            </p:cNvPr>
            <p:cNvSpPr/>
            <p:nvPr/>
          </p:nvSpPr>
          <p:spPr>
            <a:xfrm>
              <a:off x="-1959927" y="907097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tângulo 1067">
              <a:extLst>
                <a:ext uri="{FF2B5EF4-FFF2-40B4-BE49-F238E27FC236}">
                  <a16:creationId xmlns:a16="http://schemas.microsoft.com/office/drawing/2014/main" id="{CF8104C8-E579-4CB7-87F4-05ACB5E415F6}"/>
                </a:ext>
              </a:extLst>
            </p:cNvPr>
            <p:cNvSpPr/>
            <p:nvPr/>
          </p:nvSpPr>
          <p:spPr>
            <a:xfrm>
              <a:off x="1360216" y="907097"/>
              <a:ext cx="333375" cy="276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104255" tIns="52127" rIns="104255" bIns="52127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912"/>
                </a:spcAft>
              </a:pPr>
              <a:r>
                <a:rPr lang="pt-BR" sz="1368" b="1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sz="1254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Agrupar 1072">
              <a:extLst>
                <a:ext uri="{FF2B5EF4-FFF2-40B4-BE49-F238E27FC236}">
                  <a16:creationId xmlns:a16="http://schemas.microsoft.com/office/drawing/2014/main" id="{1B8A4DAA-17B5-4657-A190-9F416F696BFF}"/>
                </a:ext>
              </a:extLst>
            </p:cNvPr>
            <p:cNvGrpSpPr/>
            <p:nvPr/>
          </p:nvGrpSpPr>
          <p:grpSpPr>
            <a:xfrm>
              <a:off x="-1978977" y="907097"/>
              <a:ext cx="9904458" cy="5190490"/>
              <a:chOff x="-1988502" y="-1664653"/>
              <a:chExt cx="9904458" cy="5190490"/>
            </a:xfrm>
          </p:grpSpPr>
          <p:pic>
            <p:nvPicPr>
              <p:cNvPr id="8" name="Imagem 1062">
                <a:extLst>
                  <a:ext uri="{FF2B5EF4-FFF2-40B4-BE49-F238E27FC236}">
                    <a16:creationId xmlns:a16="http://schemas.microsoft.com/office/drawing/2014/main" id="{2BE36E91-E032-40A1-A5AD-370AC37408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0461" y="-1664653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9" name="Imagem 1063">
                <a:extLst>
                  <a:ext uri="{FF2B5EF4-FFF2-40B4-BE49-F238E27FC236}">
                    <a16:creationId xmlns:a16="http://schemas.microsoft.com/office/drawing/2014/main" id="{F27B12B3-2DDD-4F16-A1CF-F2ED791D31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988502" y="930592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0" name="Imagem 1064">
                <a:extLst>
                  <a:ext uri="{FF2B5EF4-FFF2-40B4-BE49-F238E27FC236}">
                    <a16:creationId xmlns:a16="http://schemas.microsoft.com/office/drawing/2014/main" id="{29D25A12-6011-46C3-B990-01A7C2589E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94448" y="930592"/>
                <a:ext cx="3239770" cy="2595245"/>
              </a:xfrm>
              <a:prstGeom prst="rect">
                <a:avLst/>
              </a:prstGeom>
              <a:noFill/>
            </p:spPr>
          </p:pic>
          <p:pic>
            <p:nvPicPr>
              <p:cNvPr id="11" name="Imagem 1065">
                <a:extLst>
                  <a:ext uri="{FF2B5EF4-FFF2-40B4-BE49-F238E27FC236}">
                    <a16:creationId xmlns:a16="http://schemas.microsoft.com/office/drawing/2014/main" id="{B1321B33-3256-4F88-A22D-509C1F28D1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76186" y="930592"/>
                <a:ext cx="3239770" cy="2595245"/>
              </a:xfrm>
              <a:prstGeom prst="rect">
                <a:avLst/>
              </a:prstGeom>
              <a:noFill/>
            </p:spPr>
          </p:pic>
          <p:sp>
            <p:nvSpPr>
              <p:cNvPr id="12" name="Retângulo 1068">
                <a:extLst>
                  <a:ext uri="{FF2B5EF4-FFF2-40B4-BE49-F238E27FC236}">
                    <a16:creationId xmlns:a16="http://schemas.microsoft.com/office/drawing/2014/main" id="{EE3BC161-28D5-47CB-83DE-560C6EAC555D}"/>
                  </a:ext>
                </a:extLst>
              </p:cNvPr>
              <p:cNvSpPr/>
              <p:nvPr/>
            </p:nvSpPr>
            <p:spPr>
              <a:xfrm>
                <a:off x="4676186" y="-1664653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C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tângulo 1069">
                <a:extLst>
                  <a:ext uri="{FF2B5EF4-FFF2-40B4-BE49-F238E27FC236}">
                    <a16:creationId xmlns:a16="http://schemas.microsoft.com/office/drawing/2014/main" id="{881E9F7C-CC56-4F26-A749-E45255E61F3A}"/>
                  </a:ext>
                </a:extLst>
              </p:cNvPr>
              <p:cNvSpPr/>
              <p:nvPr/>
            </p:nvSpPr>
            <p:spPr>
              <a:xfrm>
                <a:off x="-1912302" y="930592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D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tângulo 1070">
                <a:extLst>
                  <a:ext uri="{FF2B5EF4-FFF2-40B4-BE49-F238E27FC236}">
                    <a16:creationId xmlns:a16="http://schemas.microsoft.com/office/drawing/2014/main" id="{05E49594-8448-4507-B3BC-CA5B6C7E30BE}"/>
                  </a:ext>
                </a:extLst>
              </p:cNvPr>
              <p:cNvSpPr/>
              <p:nvPr/>
            </p:nvSpPr>
            <p:spPr>
              <a:xfrm>
                <a:off x="1380173" y="930592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E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tângulo 1071">
                <a:extLst>
                  <a:ext uri="{FF2B5EF4-FFF2-40B4-BE49-F238E27FC236}">
                    <a16:creationId xmlns:a16="http://schemas.microsoft.com/office/drawing/2014/main" id="{8A33D15C-3402-4953-A7B6-D7D6C7A0BBF7}"/>
                  </a:ext>
                </a:extLst>
              </p:cNvPr>
              <p:cNvSpPr/>
              <p:nvPr/>
            </p:nvSpPr>
            <p:spPr>
              <a:xfrm>
                <a:off x="4752386" y="930592"/>
                <a:ext cx="333375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104255" tIns="52127" rIns="104255" bIns="52127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912"/>
                  </a:spcAft>
                </a:pPr>
                <a:r>
                  <a:rPr lang="pt-BR" sz="1368" b="1">
                    <a:solidFill>
                      <a:srgbClr val="00000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F</a:t>
                </a:r>
                <a:endParaRPr lang="en-US" sz="1254"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" name="CaixaDeTexto 4">
            <a:extLst>
              <a:ext uri="{FF2B5EF4-FFF2-40B4-BE49-F238E27FC236}">
                <a16:creationId xmlns:a16="http://schemas.microsoft.com/office/drawing/2014/main" id="{274D6066-B211-4CBE-8169-80DF6DD4227F}"/>
              </a:ext>
            </a:extLst>
          </p:cNvPr>
          <p:cNvSpPr txBox="1"/>
          <p:nvPr/>
        </p:nvSpPr>
        <p:spPr>
          <a:xfrm>
            <a:off x="1855517" y="663876"/>
            <a:ext cx="78233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Cytoplasm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ixaDeTexto 4">
            <a:extLst>
              <a:ext uri="{FF2B5EF4-FFF2-40B4-BE49-F238E27FC236}">
                <a16:creationId xmlns:a16="http://schemas.microsoft.com/office/drawing/2014/main" id="{683A4311-68B9-4379-AC27-6B43679B1CE2}"/>
              </a:ext>
            </a:extLst>
          </p:cNvPr>
          <p:cNvSpPr txBox="1"/>
          <p:nvPr/>
        </p:nvSpPr>
        <p:spPr>
          <a:xfrm>
            <a:off x="5897347" y="663876"/>
            <a:ext cx="613181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Nuclear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ixaDeTexto 4">
            <a:extLst>
              <a:ext uri="{FF2B5EF4-FFF2-40B4-BE49-F238E27FC236}">
                <a16:creationId xmlns:a16="http://schemas.microsoft.com/office/drawing/2014/main" id="{4477183E-4958-429A-968C-8B8BBC053DDD}"/>
              </a:ext>
            </a:extLst>
          </p:cNvPr>
          <p:cNvSpPr txBox="1"/>
          <p:nvPr/>
        </p:nvSpPr>
        <p:spPr>
          <a:xfrm>
            <a:off x="9630916" y="663876"/>
            <a:ext cx="617990" cy="2326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2" b="1" spc="-3" dirty="0">
                <a:latin typeface="Arial MT"/>
                <a:cs typeface="Arial MT"/>
              </a:rPr>
              <a:t>Stromal</a:t>
            </a:r>
            <a:endParaRPr lang="pt-BR" sz="91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A03FCA7F-1B2C-48F9-BFEB-8EDE80C01E0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619060" y="3198436"/>
            <a:ext cx="863178" cy="28772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1B06C60-6EC9-4B63-9C9A-4EC4E63C912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421681" y="3199942"/>
            <a:ext cx="863178" cy="28772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9D209B6-2315-4E49-B03D-21559B7A49F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98904" y="6149283"/>
            <a:ext cx="863178" cy="28772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7668251-D032-43DA-82D2-7DEBD3A6C70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4649132" y="6151290"/>
            <a:ext cx="863178" cy="28772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A65359F-F91A-424D-B38C-25AFD664E0A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2162" t="15306" r="51425" b="79216"/>
          <a:stretch/>
        </p:blipFill>
        <p:spPr>
          <a:xfrm>
            <a:off x="8498536" y="6157306"/>
            <a:ext cx="863178" cy="287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00409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088E08D-7A9D-485E-A4FC-FA2AB1E9DA6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318" t="81907" r="25012" b="8799"/>
          <a:stretch/>
        </p:blipFill>
        <p:spPr>
          <a:xfrm>
            <a:off x="4420360" y="4955898"/>
            <a:ext cx="2848661" cy="5931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71590EB-B6B1-4F8A-B254-2F114B5A871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0966" t="22954" r="-679" b="-81"/>
          <a:stretch/>
        </p:blipFill>
        <p:spPr>
          <a:xfrm>
            <a:off x="3802743" y="1422401"/>
            <a:ext cx="3858652" cy="483325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7331C88-0C39-4111-A2CF-8A7611E85D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9065" r="83135" b="19310"/>
          <a:stretch/>
        </p:blipFill>
        <p:spPr>
          <a:xfrm>
            <a:off x="3391328" y="1893953"/>
            <a:ext cx="773164" cy="3063765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AC7D30D-3396-46B5-9B48-7261388B1F7A}"/>
              </a:ext>
            </a:extLst>
          </p:cNvPr>
          <p:cNvCxnSpPr>
            <a:cxnSpLocks/>
          </p:cNvCxnSpPr>
          <p:nvPr/>
        </p:nvCxnSpPr>
        <p:spPr>
          <a:xfrm flipH="1">
            <a:off x="7269021" y="3891038"/>
            <a:ext cx="45177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1725C8E-D0E4-4399-8DBA-0BD92D510CF3}"/>
              </a:ext>
            </a:extLst>
          </p:cNvPr>
          <p:cNvSpPr txBox="1"/>
          <p:nvPr/>
        </p:nvSpPr>
        <p:spPr>
          <a:xfrm>
            <a:off x="7731927" y="3708567"/>
            <a:ext cx="795411" cy="3356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3541"/>
            <a:r>
              <a:rPr lang="el-GR" sz="1581" dirty="0">
                <a:solidFill>
                  <a:srgbClr val="FF0000"/>
                </a:solidFill>
                <a:latin typeface="arial" panose="020B0604020202020204" pitchFamily="34" charset="0"/>
              </a:rPr>
              <a:t>β-</a:t>
            </a:r>
            <a:r>
              <a:rPr lang="en-US" sz="1581" dirty="0">
                <a:solidFill>
                  <a:srgbClr val="FF0000"/>
                </a:solidFill>
                <a:latin typeface="arial" panose="020B0604020202020204" pitchFamily="34" charset="0"/>
              </a:rPr>
              <a:t>actin</a:t>
            </a:r>
            <a:endParaRPr lang="en-US" sz="1581" dirty="0">
              <a:solidFill>
                <a:srgbClr val="FF0000"/>
              </a:solidFill>
              <a:latin typeface="Calibri" panose="020F0502020204030204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9323C02-4B7A-4226-A45A-54EEC9D53E37}"/>
              </a:ext>
            </a:extLst>
          </p:cNvPr>
          <p:cNvCxnSpPr>
            <a:cxnSpLocks/>
          </p:cNvCxnSpPr>
          <p:nvPr/>
        </p:nvCxnSpPr>
        <p:spPr>
          <a:xfrm flipH="1">
            <a:off x="7269021" y="4148806"/>
            <a:ext cx="45177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A89A9446-EEA2-45D4-B20E-A56E28257654}"/>
              </a:ext>
            </a:extLst>
          </p:cNvPr>
          <p:cNvSpPr txBox="1"/>
          <p:nvPr/>
        </p:nvSpPr>
        <p:spPr>
          <a:xfrm>
            <a:off x="7731927" y="4005001"/>
            <a:ext cx="865943" cy="3051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3541"/>
            <a:r>
              <a:rPr lang="en-US" sz="1383" dirty="0">
                <a:solidFill>
                  <a:srgbClr val="00B050"/>
                </a:solidFill>
                <a:latin typeface="arial" panose="020B0604020202020204" pitchFamily="34" charset="0"/>
              </a:rPr>
              <a:t>MASPIN</a:t>
            </a:r>
            <a:endParaRPr lang="en-US" sz="1779" dirty="0">
              <a:solidFill>
                <a:srgbClr val="00B050"/>
              </a:solidFill>
              <a:latin typeface="Calibri" panose="020F0502020204030204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2376874-9E61-07E3-19FD-A2269BCAD50B}"/>
              </a:ext>
            </a:extLst>
          </p:cNvPr>
          <p:cNvSpPr txBox="1"/>
          <p:nvPr/>
        </p:nvSpPr>
        <p:spPr>
          <a:xfrm rot="18405318">
            <a:off x="4715773" y="869695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F-10A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52A6BA-F2D4-DCDE-3436-CD538C4C49A1}"/>
              </a:ext>
            </a:extLst>
          </p:cNvPr>
          <p:cNvSpPr txBox="1"/>
          <p:nvPr/>
        </p:nvSpPr>
        <p:spPr>
          <a:xfrm rot="18405318">
            <a:off x="5344804" y="101354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F7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2204DAD-64BC-B312-44AD-B3F025CA23B2}"/>
              </a:ext>
            </a:extLst>
          </p:cNvPr>
          <p:cNvSpPr txBox="1"/>
          <p:nvPr/>
        </p:nvSpPr>
        <p:spPr>
          <a:xfrm rot="18405318">
            <a:off x="5704436" y="705302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B-231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A8C925-664C-AC69-950D-889480B3DF66}"/>
              </a:ext>
            </a:extLst>
          </p:cNvPr>
          <p:cNvSpPr txBox="1"/>
          <p:nvPr/>
        </p:nvSpPr>
        <p:spPr>
          <a:xfrm rot="18405318">
            <a:off x="6461442" y="76368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-578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616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388</Words>
  <Application>Microsoft Office PowerPoint</Application>
  <PresentationFormat>Widescreen</PresentationFormat>
  <Paragraphs>45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Arial</vt:lpstr>
      <vt:lpstr>Arial MT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queira, Otto</dc:creator>
  <cp:lastModifiedBy>Otto Luiz Dutra Cerqueira</cp:lastModifiedBy>
  <cp:revision>10</cp:revision>
  <dcterms:created xsi:type="dcterms:W3CDTF">2022-10-19T19:34:29Z</dcterms:created>
  <dcterms:modified xsi:type="dcterms:W3CDTF">2023-12-24T00:38:44Z</dcterms:modified>
</cp:coreProperties>
</file>